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jpeg" ContentType="image/jpeg"/>
  <Override PartName="/ppt/media/image5.wmf" ContentType="image/x-wmf"/>
  <Override PartName="/ppt/media/image6.png" ContentType="image/png"/>
  <Override PartName="/ppt/embeddings/oleObject1.bin" ContentType="application/vnd.openxmlformats-officedocument.oleObject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ED62E5-D315-435C-AF11-B6CEE06EE15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2659FF-CE57-4C0D-B0B2-AACB52C5CBC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735ED5-C3A4-4BB5-814A-89022FE8011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5AB624-2C52-4612-BF0A-036CB82BCDD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29B5CD-1AE4-4638-881A-9EF7A670EE6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4721F1-06AF-434B-B1A1-9C70A983FC9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5F5DAC-1CD5-4172-B630-C4C539B3749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37D648-ED75-4297-BC69-1DCC5E43456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DADEC4-D83D-47C5-AB8F-E7C8BFF125C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C1A615-56B2-406B-977D-6FAEF27B3E0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BFF460-D8C6-4FB7-82E7-90C80AE746F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3D29FE-4750-4F56-9096-3B7E402E390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2DA8270-6EEB-4A33-8F52-1839071BD8F0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jpeg"/><Relationship Id="rId5" Type="http://schemas.openxmlformats.org/officeDocument/2006/relationships/oleObject" Target="../embeddings/oleObject1.bin"/><Relationship Id="rId6" Type="http://schemas.openxmlformats.org/officeDocument/2006/relationships/image" Target="../media/image5.wmf"/><Relationship Id="rId7" Type="http://schemas.openxmlformats.org/officeDocument/2006/relationships/image" Target="../media/image6.png"/><Relationship Id="rId8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组合 1"/>
          <p:cNvGrpSpPr/>
          <p:nvPr/>
        </p:nvGrpSpPr>
        <p:grpSpPr>
          <a:xfrm>
            <a:off x="404640" y="324000"/>
            <a:ext cx="5832720" cy="8340480"/>
            <a:chOff x="404640" y="324000"/>
            <a:chExt cx="5832720" cy="8340480"/>
          </a:xfrm>
        </p:grpSpPr>
        <p:sp>
          <p:nvSpPr>
            <p:cNvPr id="42" name="TextBox 14"/>
            <p:cNvSpPr/>
            <p:nvPr/>
          </p:nvSpPr>
          <p:spPr>
            <a:xfrm>
              <a:off x="404640" y="7475400"/>
              <a:ext cx="5832720" cy="1189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Figure S1</a:t>
              </a: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. Validation of the gene silencing effect of small hairpin RNAs of XB130 (sh-XB130) and the infective efficiency of adenovirus. XB130 downregulated cells line models were confirmed by real-time PCR </a:t>
              </a: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(a)</a:t>
              </a: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and Western blot </a:t>
              </a: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(b)</a:t>
              </a: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. Cells transfected by scramble vector served as negative control, and non-transfected MOCK as control. The infective efficiency of adenovirus in 293FT cultured cells was confirmed by normal </a:t>
              </a: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(c)</a:t>
              </a: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and fluorescence </a:t>
              </a: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(d)</a:t>
              </a: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microscopies. Inset in A is the amplification curve of real-time PCR.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43" name="组合 1"/>
            <p:cNvGrpSpPr/>
            <p:nvPr/>
          </p:nvGrpSpPr>
          <p:grpSpPr>
            <a:xfrm>
              <a:off x="954360" y="324000"/>
              <a:ext cx="5146200" cy="7083000"/>
              <a:chOff x="954360" y="324000"/>
              <a:chExt cx="5146200" cy="7083000"/>
            </a:xfrm>
          </p:grpSpPr>
          <p:pic>
            <p:nvPicPr>
              <p:cNvPr id="44" name="图表 5" descr=""/>
              <p:cNvPicPr/>
              <p:nvPr/>
            </p:nvPicPr>
            <p:blipFill>
              <a:blip r:embed="rId1"/>
              <a:stretch/>
            </p:blipFill>
            <p:spPr>
              <a:xfrm>
                <a:off x="1370880" y="444960"/>
                <a:ext cx="3170160" cy="22982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45" name="TextBox 5"/>
              <p:cNvSpPr/>
              <p:nvPr/>
            </p:nvSpPr>
            <p:spPr>
              <a:xfrm rot="16200000">
                <a:off x="415800" y="1358280"/>
                <a:ext cx="1691280" cy="459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XB130 /</a:t>
                </a:r>
                <a:r>
                  <a:rPr b="0" lang="el-GR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β</a:t>
                </a: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-actin mRNA (fold of Mock)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pic>
            <p:nvPicPr>
              <p:cNvPr id="46" name="图片 7" descr=""/>
              <p:cNvPicPr/>
              <p:nvPr/>
            </p:nvPicPr>
            <p:blipFill>
              <a:blip r:embed="rId2"/>
              <a:stretch/>
            </p:blipFill>
            <p:spPr>
              <a:xfrm>
                <a:off x="3489480" y="324000"/>
                <a:ext cx="2297160" cy="12160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47" name="Picture 2" descr=""/>
              <p:cNvPicPr/>
              <p:nvPr/>
            </p:nvPicPr>
            <p:blipFill>
              <a:blip r:embed="rId3"/>
              <a:stretch/>
            </p:blipFill>
            <p:spPr>
              <a:xfrm>
                <a:off x="3645360" y="4919400"/>
                <a:ext cx="2095200" cy="20098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48" name="Picture 3" descr=""/>
              <p:cNvPicPr/>
              <p:nvPr/>
            </p:nvPicPr>
            <p:blipFill>
              <a:blip r:embed="rId4"/>
              <a:stretch/>
            </p:blipFill>
            <p:spPr>
              <a:xfrm>
                <a:off x="1250280" y="4919400"/>
                <a:ext cx="2095200" cy="20059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49" name="矩形 3"/>
              <p:cNvSpPr/>
              <p:nvPr/>
            </p:nvSpPr>
            <p:spPr>
              <a:xfrm>
                <a:off x="1328040" y="6948000"/>
                <a:ext cx="1999800" cy="459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293FT cultured cells under ordinary light microscopy 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0" name="矩形 3"/>
              <p:cNvSpPr/>
              <p:nvPr/>
            </p:nvSpPr>
            <p:spPr>
              <a:xfrm>
                <a:off x="3788280" y="6948000"/>
                <a:ext cx="2160360" cy="459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293FT cultured cells under fluorescence microscopy 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1" name="TextBox 10"/>
              <p:cNvSpPr/>
              <p:nvPr/>
            </p:nvSpPr>
            <p:spPr>
              <a:xfrm>
                <a:off x="1072800" y="383400"/>
                <a:ext cx="2707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a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2" name="TextBox 11"/>
              <p:cNvSpPr/>
              <p:nvPr/>
            </p:nvSpPr>
            <p:spPr>
              <a:xfrm>
                <a:off x="1085040" y="2847600"/>
                <a:ext cx="2797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b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3" name="TextBox 12"/>
              <p:cNvSpPr/>
              <p:nvPr/>
            </p:nvSpPr>
            <p:spPr>
              <a:xfrm>
                <a:off x="954360" y="4807080"/>
                <a:ext cx="2599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4" name="TextBox 13"/>
              <p:cNvSpPr/>
              <p:nvPr/>
            </p:nvSpPr>
            <p:spPr>
              <a:xfrm>
                <a:off x="3408480" y="4775400"/>
                <a:ext cx="2797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d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grpSp>
            <p:nvGrpSpPr>
              <p:cNvPr id="55" name="Group 18"/>
              <p:cNvGrpSpPr/>
              <p:nvPr/>
            </p:nvGrpSpPr>
            <p:grpSpPr>
              <a:xfrm>
                <a:off x="1299600" y="2867040"/>
                <a:ext cx="3424320" cy="1949040"/>
                <a:chOff x="1299600" y="2867040"/>
                <a:chExt cx="3424320" cy="1949040"/>
              </a:xfrm>
            </p:grpSpPr>
            <p:graphicFrame>
              <p:nvGraphicFramePr>
                <p:cNvPr id="56" name="Object 5"/>
                <p:cNvGraphicFramePr/>
                <p:nvPr/>
              </p:nvGraphicFramePr>
              <p:xfrm>
                <a:off x="1490760" y="2867040"/>
                <a:ext cx="3233160" cy="1949040"/>
              </p:xfrm>
              <a:graphic>
                <a:graphicData uri="http://schemas.openxmlformats.org/presentationml/2006/ole">
                  <p:oleObj r:id="rId5" spid="">
                    <p:embed/>
                    <p:pic>
                      <p:nvPicPr>
                        <p:cNvPr id="57" name="Object 5" descr=""/>
                        <p:cNvPicPr/>
                        <p:nvPr/>
                      </p:nvPicPr>
                      <p:blipFill>
                        <a:blip r:embed="rId6"/>
                        <a:stretch/>
                      </p:blipFill>
                      <p:spPr>
                        <a:xfrm>
                          <a:off x="1490760" y="2867040"/>
                          <a:ext cx="3233160" cy="1949040"/>
                        </a:xfrm>
                        <a:prstGeom prst="rect">
                          <a:avLst/>
                        </a:prstGeom>
                        <a:ln w="0">
                          <a:noFill/>
                        </a:ln>
                      </p:spPr>
                    </p:pic>
                  </p:oleObj>
                </a:graphicData>
              </a:graphic>
            </p:graphicFrame>
            <p:sp>
              <p:nvSpPr>
                <p:cNvPr id="58" name="Text Box 8"/>
                <p:cNvSpPr/>
                <p:nvPr/>
              </p:nvSpPr>
              <p:spPr>
                <a:xfrm rot="16200000">
                  <a:off x="893880" y="3648600"/>
                  <a:ext cx="108756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XB130/</a:t>
                  </a:r>
                  <a:r>
                    <a:rPr b="0" lang="en-US" sz="1200" spc="-1" strike="noStrike">
                      <a:solidFill>
                        <a:srgbClr val="000000"/>
                      </a:solidFill>
                      <a:latin typeface="Times New Roman"/>
                      <a:ea typeface="Dotum"/>
                    </a:rPr>
                    <a:t>β</a:t>
                  </a:r>
                  <a:r>
                    <a:rPr b="0" lang="en-US" sz="12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-actin</a:t>
                  </a:r>
                  <a:endParaRPr b="0" lang="en-US" sz="12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59" name="Group 16"/>
              <p:cNvGrpSpPr/>
              <p:nvPr/>
            </p:nvGrpSpPr>
            <p:grpSpPr>
              <a:xfrm>
                <a:off x="3466800" y="2745720"/>
                <a:ext cx="2633760" cy="931680"/>
                <a:chOff x="3466800" y="2745720"/>
                <a:chExt cx="2633760" cy="931680"/>
              </a:xfrm>
            </p:grpSpPr>
            <p:pic>
              <p:nvPicPr>
                <p:cNvPr id="60" name="Picture 10" descr="siXB130 筛选"/>
                <p:cNvPicPr/>
                <p:nvPr/>
              </p:nvPicPr>
              <p:blipFill>
                <a:blip r:embed="rId7"/>
                <a:stretch/>
              </p:blipFill>
              <p:spPr>
                <a:xfrm>
                  <a:off x="3466800" y="2753280"/>
                  <a:ext cx="2633760" cy="92412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61" name="Text Box 11"/>
                <p:cNvSpPr/>
                <p:nvPr/>
              </p:nvSpPr>
              <p:spPr>
                <a:xfrm>
                  <a:off x="3603600" y="3073680"/>
                  <a:ext cx="62100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XB130</a:t>
                  </a:r>
                  <a:endParaRPr b="0" lang="en-US" sz="12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2" name="Text Box 12"/>
                <p:cNvSpPr/>
                <p:nvPr/>
              </p:nvSpPr>
              <p:spPr>
                <a:xfrm>
                  <a:off x="3617640" y="3353400"/>
                  <a:ext cx="60444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Times New Roman"/>
                      <a:ea typeface="Dotum"/>
                    </a:rPr>
                    <a:t>β</a:t>
                  </a:r>
                  <a:r>
                    <a:rPr b="0" lang="en-US" sz="12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-actin</a:t>
                  </a:r>
                  <a:endParaRPr b="0" lang="en-US" sz="12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3" name="Text Box 13"/>
                <p:cNvSpPr/>
                <p:nvPr/>
              </p:nvSpPr>
              <p:spPr>
                <a:xfrm>
                  <a:off x="4059360" y="2828520"/>
                  <a:ext cx="112716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MOCK   scramble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4" name="Text Box 14"/>
                <p:cNvSpPr/>
                <p:nvPr/>
              </p:nvSpPr>
              <p:spPr>
                <a:xfrm>
                  <a:off x="5204160" y="2745720"/>
                  <a:ext cx="744480" cy="2311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900" spc="-1" strike="noStrike">
                      <a:solidFill>
                        <a:srgbClr val="000000"/>
                      </a:solidFill>
                      <a:latin typeface="Calibri"/>
                    </a:rPr>
                    <a:t>sh-XB130</a:t>
                  </a:r>
                  <a:endParaRPr b="0" lang="en-US" sz="9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5" name="Text Box 15"/>
                <p:cNvSpPr/>
                <p:nvPr/>
              </p:nvSpPr>
              <p:spPr>
                <a:xfrm>
                  <a:off x="4982400" y="2885040"/>
                  <a:ext cx="1117800" cy="2311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9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1              2          3</a:t>
                  </a:r>
                  <a:endParaRPr b="0" lang="en-US" sz="9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03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11-02T09:31:05Z</dcterms:created>
  <dc:creator>Liao YL</dc:creator>
  <dc:description/>
  <dc:language>en-US</dc:language>
  <cp:lastModifiedBy>Liao YL</cp:lastModifiedBy>
  <dcterms:modified xsi:type="dcterms:W3CDTF">2012-07-09T01:22:39Z</dcterms:modified>
  <cp:revision>81</cp:revision>
  <dc:subject/>
  <dc:title>PowerPoint 演示文稿</dc:title>
</cp:coreProperties>
</file>